
<file path=[Content_Types].xml><?xml version="1.0" encoding="utf-8"?>
<Types xmlns="http://schemas.openxmlformats.org/package/2006/content-types"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8"/>
  </p:notesMasterIdLst>
  <p:handoutMasterIdLst>
    <p:handoutMasterId r:id="rId9"/>
  </p:handoutMasterIdLst>
  <p:sldIdLst>
    <p:sldId id="259" r:id="rId5"/>
    <p:sldId id="279" r:id="rId6"/>
    <p:sldId id="288" r:id="rId7"/>
  </p:sldIdLst>
  <p:sldSz cx="6858000" cy="9906000" type="A4"/>
  <p:notesSz cx="9855200" cy="67183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02">
          <p15:clr>
            <a:srgbClr val="A4A3A4"/>
          </p15:clr>
        </p15:guide>
        <p15:guide id="2" pos="845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ea Patasic" initials="LP" lastIdx="8" clrIdx="0"/>
  <p:cmAuthor id="2" name="Seifried, Janna" initials="JS" lastIdx="3" clrIdx="1"/>
  <p:cmAuthor id="3" name="Lea" initials="LP" lastIdx="5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1" d="100"/>
          <a:sy n="71" d="100"/>
        </p:scale>
        <p:origin x="-1626" y="-90"/>
      </p:cViewPr>
      <p:guideLst>
        <p:guide orient="horz" pos="2802"/>
        <p:guide pos="84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openxmlformats.org/officeDocument/2006/relationships/commentAuthors" Target="commentAuthors.xml"/><Relationship Id="rId4" Type="http://schemas.openxmlformats.org/officeDocument/2006/relationships/slideMaster" Target="slideMasters/slideMaster1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270897" cy="33548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581976" y="0"/>
            <a:ext cx="4270897" cy="33548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1B7625-91B0-4E7B-9A9D-99D4A6AA75FD}" type="datetimeFigureOut">
              <a:rPr lang="en-US" smtClean="0"/>
              <a:pPr/>
              <a:t>8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6381736"/>
            <a:ext cx="4270897" cy="33548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581976" y="6381736"/>
            <a:ext cx="4270897" cy="33548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E3B7CDB-A048-45CC-8982-C1D3B05CF7A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0001157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" y="0"/>
            <a:ext cx="4271276" cy="335701"/>
          </a:xfrm>
          <a:prstGeom prst="rect">
            <a:avLst/>
          </a:prstGeom>
        </p:spPr>
        <p:txBody>
          <a:bodyPr vert="horz" lIns="90461" tIns="45229" rIns="90461" bIns="4522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581628" y="0"/>
            <a:ext cx="4271276" cy="335701"/>
          </a:xfrm>
          <a:prstGeom prst="rect">
            <a:avLst/>
          </a:prstGeom>
        </p:spPr>
        <p:txBody>
          <a:bodyPr vert="horz" lIns="90461" tIns="45229" rIns="90461" bIns="45229" rtlCol="0"/>
          <a:lstStyle>
            <a:lvl1pPr algn="r">
              <a:defRPr sz="1200"/>
            </a:lvl1pPr>
          </a:lstStyle>
          <a:p>
            <a:fld id="{5262ADF5-AD16-42BB-9BBD-CCE255778E77}" type="datetimeFigureOut">
              <a:rPr lang="en-US" smtClean="0"/>
              <a:pPr/>
              <a:t>8/2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056063" y="504825"/>
            <a:ext cx="1744662" cy="25193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461" tIns="45229" rIns="90461" bIns="4522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86213" y="3190764"/>
            <a:ext cx="7882780" cy="3023449"/>
          </a:xfrm>
          <a:prstGeom prst="rect">
            <a:avLst/>
          </a:prstGeom>
        </p:spPr>
        <p:txBody>
          <a:bodyPr vert="horz" lIns="90461" tIns="45229" rIns="90461" bIns="4522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" y="6381527"/>
            <a:ext cx="4271276" cy="335701"/>
          </a:xfrm>
          <a:prstGeom prst="rect">
            <a:avLst/>
          </a:prstGeom>
        </p:spPr>
        <p:txBody>
          <a:bodyPr vert="horz" lIns="90461" tIns="45229" rIns="90461" bIns="4522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581628" y="6381527"/>
            <a:ext cx="4271276" cy="335701"/>
          </a:xfrm>
          <a:prstGeom prst="rect">
            <a:avLst/>
          </a:prstGeom>
        </p:spPr>
        <p:txBody>
          <a:bodyPr vert="horz" lIns="90461" tIns="45229" rIns="90461" bIns="45229" rtlCol="0" anchor="b"/>
          <a:lstStyle>
            <a:lvl1pPr algn="r">
              <a:defRPr sz="1200"/>
            </a:lvl1pPr>
          </a:lstStyle>
          <a:p>
            <a:fld id="{D5E3A373-2334-44EF-ADE9-F661899BBD3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681755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5E3A373-2334-44EF-ADE9-F661899BBD39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975458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3803A-0BCE-4340-9819-013ED9276CD6}" type="datetimeFigureOut">
              <a:rPr lang="en-US" smtClean="0"/>
              <a:pPr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9EC3E-0564-4BCB-A1FC-A06E304D456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9252063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3803A-0BCE-4340-9819-013ED9276CD6}" type="datetimeFigureOut">
              <a:rPr lang="en-US" smtClean="0"/>
              <a:pPr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9EC3E-0564-4BCB-A1FC-A06E304D456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841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3803A-0BCE-4340-9819-013ED9276CD6}" type="datetimeFigureOut">
              <a:rPr lang="en-US" smtClean="0"/>
              <a:pPr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9EC3E-0564-4BCB-A1FC-A06E304D456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4763065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3803A-0BCE-4340-9819-013ED9276CD6}" type="datetimeFigureOut">
              <a:rPr lang="en-US" smtClean="0"/>
              <a:pPr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9EC3E-0564-4BCB-A1FC-A06E304D456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494616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3803A-0BCE-4340-9819-013ED9276CD6}" type="datetimeFigureOut">
              <a:rPr lang="en-US" smtClean="0"/>
              <a:pPr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9EC3E-0564-4BCB-A1FC-A06E304D456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162395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3803A-0BCE-4340-9819-013ED9276CD6}" type="datetimeFigureOut">
              <a:rPr lang="en-US" smtClean="0"/>
              <a:pPr/>
              <a:t>8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9EC3E-0564-4BCB-A1FC-A06E304D456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7710270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3803A-0BCE-4340-9819-013ED9276CD6}" type="datetimeFigureOut">
              <a:rPr lang="en-US" smtClean="0"/>
              <a:pPr/>
              <a:t>8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9EC3E-0564-4BCB-A1FC-A06E304D456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856263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3803A-0BCE-4340-9819-013ED9276CD6}" type="datetimeFigureOut">
              <a:rPr lang="en-US" smtClean="0"/>
              <a:pPr/>
              <a:t>8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9EC3E-0564-4BCB-A1FC-A06E304D456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5478207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3803A-0BCE-4340-9819-013ED9276CD6}" type="datetimeFigureOut">
              <a:rPr lang="en-US" smtClean="0"/>
              <a:pPr/>
              <a:t>8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9EC3E-0564-4BCB-A1FC-A06E304D456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64864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3803A-0BCE-4340-9819-013ED9276CD6}" type="datetimeFigureOut">
              <a:rPr lang="en-US" smtClean="0"/>
              <a:pPr/>
              <a:t>8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9EC3E-0564-4BCB-A1FC-A06E304D456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91422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D3803A-0BCE-4340-9819-013ED9276CD6}" type="datetimeFigureOut">
              <a:rPr lang="en-US" smtClean="0"/>
              <a:pPr/>
              <a:t>8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9EC3E-0564-4BCB-A1FC-A06E304D456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941729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D3803A-0BCE-4340-9819-013ED9276CD6}" type="datetimeFigureOut">
              <a:rPr lang="en-US" smtClean="0"/>
              <a:pPr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99EC3E-0564-4BCB-A1FC-A06E304D456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570340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3" Type="http://schemas.openxmlformats.org/officeDocument/2006/relationships/image" Target="../media/image10.emf"/><Relationship Id="rId7" Type="http://schemas.openxmlformats.org/officeDocument/2006/relationships/image" Target="../media/image14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emf"/><Relationship Id="rId11" Type="http://schemas.openxmlformats.org/officeDocument/2006/relationships/image" Target="../media/image18.emf"/><Relationship Id="rId5" Type="http://schemas.openxmlformats.org/officeDocument/2006/relationships/image" Target="../media/image12.emf"/><Relationship Id="rId10" Type="http://schemas.openxmlformats.org/officeDocument/2006/relationships/image" Target="../media/image17.emf"/><Relationship Id="rId4" Type="http://schemas.openxmlformats.org/officeDocument/2006/relationships/image" Target="../media/image11.emf"/><Relationship Id="rId9" Type="http://schemas.openxmlformats.org/officeDocument/2006/relationships/image" Target="../media/image1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764704" y="1507647"/>
            <a:ext cx="3632050" cy="2166004"/>
            <a:chOff x="764704" y="1507647"/>
            <a:chExt cx="3632050" cy="2166004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780928" y="1734604"/>
              <a:ext cx="1615826" cy="1620000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1124744" y="1734604"/>
              <a:ext cx="1776891" cy="1620000"/>
            </a:xfrm>
            <a:prstGeom prst="rect">
              <a:avLst/>
            </a:prstGeom>
          </p:spPr>
        </p:pic>
        <p:grpSp>
          <p:nvGrpSpPr>
            <p:cNvPr id="13" name="Group 12"/>
            <p:cNvGrpSpPr/>
            <p:nvPr/>
          </p:nvGrpSpPr>
          <p:grpSpPr>
            <a:xfrm>
              <a:off x="764704" y="1507647"/>
              <a:ext cx="3632050" cy="2166004"/>
              <a:chOff x="369604" y="1851390"/>
              <a:chExt cx="3632050" cy="2166004"/>
            </a:xfrm>
          </p:grpSpPr>
          <p:sp>
            <p:nvSpPr>
              <p:cNvPr id="16" name="TextBox 15"/>
              <p:cNvSpPr txBox="1"/>
              <p:nvPr/>
            </p:nvSpPr>
            <p:spPr>
              <a:xfrm>
                <a:off x="2745868" y="1851390"/>
                <a:ext cx="10207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u="sng" dirty="0"/>
                  <a:t>aCD4-DARPin</a:t>
                </a:r>
                <a:endParaRPr lang="en-US" sz="1200" u="sng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1275614" y="1851392"/>
                <a:ext cx="8572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200" u="sng" dirty="0" err="1"/>
                  <a:t>nc-DARPin</a:t>
                </a:r>
                <a:endParaRPr lang="en-US" sz="1200" u="sng" dirty="0"/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 rot="16200000">
                <a:off x="301317" y="2775479"/>
                <a:ext cx="4443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400" dirty="0"/>
                  <a:t>SSC</a:t>
                </a:r>
                <a:endParaRPr lang="en-US" sz="1400" dirty="0"/>
              </a:p>
            </p:txBody>
          </p:sp>
          <p:cxnSp>
            <p:nvCxnSpPr>
              <p:cNvPr id="27" name="Straight Arrow Connector 26"/>
              <p:cNvCxnSpPr/>
              <p:nvPr/>
            </p:nvCxnSpPr>
            <p:spPr>
              <a:xfrm>
                <a:off x="668363" y="3712567"/>
                <a:ext cx="3333291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" name="Straight Arrow Connector 4"/>
              <p:cNvCxnSpPr/>
              <p:nvPr/>
            </p:nvCxnSpPr>
            <p:spPr>
              <a:xfrm flipV="1">
                <a:off x="677382" y="2092567"/>
                <a:ext cx="0" cy="162000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TextBox 33"/>
              <p:cNvSpPr txBox="1"/>
              <p:nvPr/>
            </p:nvSpPr>
            <p:spPr>
              <a:xfrm>
                <a:off x="1837629" y="3709617"/>
                <a:ext cx="99475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400" dirty="0"/>
                  <a:t>DARPin-HA</a:t>
                </a:r>
                <a:endParaRPr lang="en-US" sz="1400" dirty="0"/>
              </a:p>
            </p:txBody>
          </p:sp>
        </p:grpSp>
        <p:sp>
          <p:nvSpPr>
            <p:cNvPr id="37" name="TextBox 36"/>
            <p:cNvSpPr txBox="1"/>
            <p:nvPr/>
          </p:nvSpPr>
          <p:spPr>
            <a:xfrm>
              <a:off x="3891487" y="1811481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1000" dirty="0"/>
                <a:t>37,9%</a:t>
              </a:r>
              <a:endParaRPr lang="en-US" sz="1000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462091" y="1811481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1000" dirty="0"/>
                <a:t>0,5%</a:t>
              </a:r>
              <a:endParaRPr lang="en-US" sz="1000" dirty="0"/>
            </a:p>
          </p:txBody>
        </p:sp>
      </p:grpSp>
      <p:sp>
        <p:nvSpPr>
          <p:cNvPr id="15" name="TextBox 14"/>
          <p:cNvSpPr txBox="1"/>
          <p:nvPr/>
        </p:nvSpPr>
        <p:spPr>
          <a:xfrm>
            <a:off x="764704" y="3852495"/>
            <a:ext cx="36320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Supplementary Figure 1. Lack of specific binding of </a:t>
            </a:r>
            <a:r>
              <a:rPr lang="en-US" sz="1000" b="1" dirty="0" err="1"/>
              <a:t>nc-DARPin</a:t>
            </a:r>
            <a:r>
              <a:rPr lang="en-US" sz="1000" b="1" dirty="0"/>
              <a:t> to human PBMCs.</a:t>
            </a:r>
            <a:endParaRPr lang="de-DE" sz="1000" b="1" dirty="0"/>
          </a:p>
        </p:txBody>
      </p:sp>
    </p:spTree>
    <p:extLst>
      <p:ext uri="{BB962C8B-B14F-4D97-AF65-F5344CB8AC3E}">
        <p14:creationId xmlns:p14="http://schemas.microsoft.com/office/powerpoint/2010/main" xmlns="" val="23195076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/>
          <p:cNvGrpSpPr/>
          <p:nvPr/>
        </p:nvGrpSpPr>
        <p:grpSpPr>
          <a:xfrm>
            <a:off x="904461" y="6304536"/>
            <a:ext cx="3797935" cy="261610"/>
            <a:chOff x="404664" y="9111272"/>
            <a:chExt cx="5165737" cy="355828"/>
          </a:xfrm>
        </p:grpSpPr>
        <p:grpSp>
          <p:nvGrpSpPr>
            <p:cNvPr id="15" name="Group 14"/>
            <p:cNvGrpSpPr/>
            <p:nvPr/>
          </p:nvGrpSpPr>
          <p:grpSpPr>
            <a:xfrm>
              <a:off x="404664" y="9111272"/>
              <a:ext cx="1200823" cy="355828"/>
              <a:chOff x="404664" y="9094579"/>
              <a:chExt cx="1200823" cy="355828"/>
            </a:xfrm>
          </p:grpSpPr>
          <p:sp>
            <p:nvSpPr>
              <p:cNvPr id="4" name="Rectangle 3"/>
              <p:cNvSpPr/>
              <p:nvPr/>
            </p:nvSpPr>
            <p:spPr>
              <a:xfrm>
                <a:off x="404664" y="9182493"/>
                <a:ext cx="180000" cy="180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584664" y="9094579"/>
                <a:ext cx="1020823" cy="355828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de-DE" sz="1100" dirty="0" err="1"/>
                  <a:t>unstained</a:t>
                </a:r>
                <a:endParaRPr lang="en-US" sz="1100" dirty="0"/>
              </a:p>
            </p:txBody>
          </p:sp>
        </p:grpSp>
        <p:grpSp>
          <p:nvGrpSpPr>
            <p:cNvPr id="19" name="Group 18"/>
            <p:cNvGrpSpPr/>
            <p:nvPr/>
          </p:nvGrpSpPr>
          <p:grpSpPr>
            <a:xfrm>
              <a:off x="3932105" y="9111272"/>
              <a:ext cx="1638296" cy="355828"/>
              <a:chOff x="4452407" y="9127966"/>
              <a:chExt cx="1638296" cy="355828"/>
            </a:xfrm>
          </p:grpSpPr>
          <p:sp>
            <p:nvSpPr>
              <p:cNvPr id="24" name="TextBox 23"/>
              <p:cNvSpPr txBox="1"/>
              <p:nvPr/>
            </p:nvSpPr>
            <p:spPr>
              <a:xfrm>
                <a:off x="4849668" y="9127966"/>
                <a:ext cx="1241035" cy="355828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de-DE" sz="1100" dirty="0"/>
                  <a:t>CD30 </a:t>
                </a:r>
                <a:r>
                  <a:rPr lang="de-DE" sz="1100" dirty="0" err="1"/>
                  <a:t>or</a:t>
                </a:r>
                <a:r>
                  <a:rPr lang="de-DE" sz="1100" dirty="0"/>
                  <a:t> CD4</a:t>
                </a:r>
                <a:endParaRPr lang="en-US" sz="1100" dirty="0"/>
              </a:p>
            </p:txBody>
          </p:sp>
          <p:cxnSp>
            <p:nvCxnSpPr>
              <p:cNvPr id="14" name="Straight Connector 13"/>
              <p:cNvCxnSpPr/>
              <p:nvPr/>
            </p:nvCxnSpPr>
            <p:spPr>
              <a:xfrm>
                <a:off x="4452407" y="9305880"/>
                <a:ext cx="396000" cy="0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" name="Group 15"/>
            <p:cNvGrpSpPr/>
            <p:nvPr/>
          </p:nvGrpSpPr>
          <p:grpSpPr>
            <a:xfrm>
              <a:off x="1879574" y="9111272"/>
              <a:ext cx="1811462" cy="355828"/>
              <a:chOff x="1870892" y="9094578"/>
              <a:chExt cx="1811462" cy="355828"/>
            </a:xfrm>
          </p:grpSpPr>
          <p:sp>
            <p:nvSpPr>
              <p:cNvPr id="5" name="TextBox 4"/>
              <p:cNvSpPr txBox="1"/>
              <p:nvPr/>
            </p:nvSpPr>
            <p:spPr>
              <a:xfrm>
                <a:off x="2266894" y="9094578"/>
                <a:ext cx="1415460" cy="355828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de-DE" sz="1100" dirty="0" err="1"/>
                  <a:t>isotype</a:t>
                </a:r>
                <a:r>
                  <a:rPr lang="de-DE" sz="1100" dirty="0"/>
                  <a:t> </a:t>
                </a:r>
                <a:r>
                  <a:rPr lang="de-DE" sz="1100" dirty="0" err="1"/>
                  <a:t>control</a:t>
                </a:r>
                <a:endParaRPr lang="en-US" sz="1100" dirty="0"/>
              </a:p>
            </p:txBody>
          </p:sp>
          <p:cxnSp>
            <p:nvCxnSpPr>
              <p:cNvPr id="26" name="Straight Connector 25"/>
              <p:cNvCxnSpPr/>
              <p:nvPr/>
            </p:nvCxnSpPr>
            <p:spPr>
              <a:xfrm>
                <a:off x="1870892" y="9272492"/>
                <a:ext cx="396001" cy="0"/>
              </a:xfrm>
              <a:prstGeom prst="line">
                <a:avLst/>
              </a:prstGeom>
              <a:ln w="571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7" name="TextBox 16"/>
          <p:cNvSpPr txBox="1"/>
          <p:nvPr/>
        </p:nvSpPr>
        <p:spPr>
          <a:xfrm rot="16200000" flipH="1">
            <a:off x="4976671" y="1349718"/>
            <a:ext cx="6655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HuT78</a:t>
            </a:r>
            <a:endParaRPr lang="en-US" sz="1400" b="1" dirty="0"/>
          </a:p>
        </p:txBody>
      </p:sp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896960" y="718473"/>
            <a:ext cx="2329635" cy="18527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1" name="TextBox 30"/>
          <p:cNvSpPr txBox="1"/>
          <p:nvPr/>
        </p:nvSpPr>
        <p:spPr>
          <a:xfrm rot="16200000" flipH="1">
            <a:off x="5076858" y="3202463"/>
            <a:ext cx="4651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Raji</a:t>
            </a:r>
            <a:endParaRPr lang="en-US" sz="1400" b="1" dirty="0"/>
          </a:p>
        </p:txBody>
      </p:sp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896960" y="2571218"/>
            <a:ext cx="2329635" cy="18527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" name="TextBox 29"/>
          <p:cNvSpPr txBox="1"/>
          <p:nvPr/>
        </p:nvSpPr>
        <p:spPr>
          <a:xfrm rot="16200000" flipH="1">
            <a:off x="5048038" y="5055208"/>
            <a:ext cx="5228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J-Lat</a:t>
            </a:r>
            <a:endParaRPr lang="en-US" sz="1400" b="1" dirty="0"/>
          </a:p>
        </p:txBody>
      </p:sp>
      <p:pic>
        <p:nvPicPr>
          <p:cNvPr id="1038" name="Picture 1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896960" y="4423963"/>
            <a:ext cx="2329635" cy="18527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32861" y="718473"/>
            <a:ext cx="2329635" cy="18527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20688" y="2571218"/>
            <a:ext cx="2329635" cy="18527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9" name="Picture 15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32861" y="4423963"/>
            <a:ext cx="2329635" cy="18527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5" name="TextBox 24"/>
          <p:cNvSpPr txBox="1"/>
          <p:nvPr/>
        </p:nvSpPr>
        <p:spPr>
          <a:xfrm>
            <a:off x="620688" y="6693386"/>
            <a:ext cx="48245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/>
              <a:t>Supplementary Figure 2.</a:t>
            </a:r>
            <a:r>
              <a:rPr lang="en-US" sz="1000" dirty="0"/>
              <a:t> </a:t>
            </a:r>
            <a:r>
              <a:rPr lang="en-US" sz="1000" b="1" dirty="0"/>
              <a:t>Expression of CAR cognate antigens on the surface of HuT78, Raji and J-Lat cells.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xmlns="" val="20380398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446761" y="1424768"/>
            <a:ext cx="4881267" cy="6264536"/>
            <a:chOff x="446761" y="1424768"/>
            <a:chExt cx="4881267" cy="6264536"/>
          </a:xfrm>
        </p:grpSpPr>
        <p:sp>
          <p:nvSpPr>
            <p:cNvPr id="6" name="TextBox 5"/>
            <p:cNvSpPr txBox="1"/>
            <p:nvPr/>
          </p:nvSpPr>
          <p:spPr>
            <a:xfrm>
              <a:off x="2243233" y="1929325"/>
              <a:ext cx="909223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 err="1"/>
                <a:t>before</a:t>
              </a:r>
              <a:r>
                <a:rPr lang="de-DE" sz="1100" dirty="0"/>
                <a:t> </a:t>
              </a:r>
            </a:p>
            <a:p>
              <a:r>
                <a:rPr lang="de-DE" sz="1100" dirty="0" err="1"/>
                <a:t>transduction</a:t>
              </a:r>
              <a:endParaRPr lang="en-US" sz="11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552638" y="2937356"/>
              <a:ext cx="8002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u="sng" dirty="0"/>
                <a:t>aCD30scFv</a:t>
              </a:r>
              <a:endParaRPr lang="en-US" sz="1100" u="sng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053969" y="2937356"/>
              <a:ext cx="93487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u="sng" dirty="0"/>
                <a:t>mock control</a:t>
              </a:r>
              <a:endParaRPr lang="en-US" sz="1100" u="sng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916655" y="2937356"/>
              <a:ext cx="95250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u="sng" dirty="0"/>
                <a:t>aCD4-DARPin</a:t>
              </a:r>
              <a:endParaRPr lang="en-US" sz="1100" u="sng" dirty="0"/>
            </a:p>
          </p:txBody>
        </p:sp>
        <p:sp>
          <p:nvSpPr>
            <p:cNvPr id="19" name="TextBox 18"/>
            <p:cNvSpPr txBox="1"/>
            <p:nvPr/>
          </p:nvSpPr>
          <p:spPr>
            <a:xfrm flipH="1">
              <a:off x="4927918" y="3628569"/>
              <a:ext cx="400110" cy="483338"/>
            </a:xfrm>
            <a:prstGeom prst="rect">
              <a:avLst/>
            </a:prstGeom>
            <a:noFill/>
          </p:spPr>
          <p:txBody>
            <a:bodyPr vert="vert270" wrap="none" rtlCol="0" anchor="ctr">
              <a:spAutoFit/>
            </a:bodyPr>
            <a:lstStyle/>
            <a:p>
              <a:pPr algn="ctr"/>
              <a:r>
                <a:rPr lang="de-DE" sz="1400" dirty="0" err="1"/>
                <a:t>day</a:t>
              </a:r>
              <a:r>
                <a:rPr lang="de-DE" sz="1400" dirty="0"/>
                <a:t> 3</a:t>
              </a:r>
              <a:endParaRPr lang="en-US" sz="1400" dirty="0"/>
            </a:p>
          </p:txBody>
        </p:sp>
        <p:sp>
          <p:nvSpPr>
            <p:cNvPr id="20" name="TextBox 19"/>
            <p:cNvSpPr txBox="1"/>
            <p:nvPr/>
          </p:nvSpPr>
          <p:spPr>
            <a:xfrm flipH="1">
              <a:off x="4927918" y="5013352"/>
              <a:ext cx="400110" cy="483338"/>
            </a:xfrm>
            <a:prstGeom prst="rect">
              <a:avLst/>
            </a:prstGeom>
            <a:noFill/>
          </p:spPr>
          <p:txBody>
            <a:bodyPr vert="vert270" wrap="none" rtlCol="0" anchor="ctr">
              <a:spAutoFit/>
            </a:bodyPr>
            <a:lstStyle/>
            <a:p>
              <a:pPr algn="ctr"/>
              <a:r>
                <a:rPr lang="de-DE" sz="1400" dirty="0" err="1"/>
                <a:t>day</a:t>
              </a:r>
              <a:r>
                <a:rPr lang="de-DE" sz="1400" dirty="0"/>
                <a:t> 5</a:t>
              </a:r>
              <a:endParaRPr lang="en-US" sz="1400" dirty="0"/>
            </a:p>
          </p:txBody>
        </p:sp>
        <p:sp>
          <p:nvSpPr>
            <p:cNvPr id="21" name="TextBox 20"/>
            <p:cNvSpPr txBox="1"/>
            <p:nvPr/>
          </p:nvSpPr>
          <p:spPr>
            <a:xfrm flipH="1">
              <a:off x="4927918" y="6394447"/>
              <a:ext cx="400110" cy="483338"/>
            </a:xfrm>
            <a:prstGeom prst="rect">
              <a:avLst/>
            </a:prstGeom>
            <a:noFill/>
          </p:spPr>
          <p:txBody>
            <a:bodyPr vert="vert270" wrap="none" rtlCol="0" anchor="ctr">
              <a:spAutoFit/>
            </a:bodyPr>
            <a:lstStyle/>
            <a:p>
              <a:pPr algn="ctr"/>
              <a:r>
                <a:rPr lang="de-DE" sz="1400" dirty="0" err="1"/>
                <a:t>day</a:t>
              </a:r>
              <a:r>
                <a:rPr lang="de-DE" sz="1400" dirty="0"/>
                <a:t> 8</a:t>
              </a:r>
              <a:endParaRPr lang="en-US" sz="1400" dirty="0"/>
            </a:p>
          </p:txBody>
        </p:sp>
        <p:cxnSp>
          <p:nvCxnSpPr>
            <p:cNvPr id="5" name="Straight Arrow Connector 4"/>
            <p:cNvCxnSpPr/>
            <p:nvPr/>
          </p:nvCxnSpPr>
          <p:spPr>
            <a:xfrm flipV="1">
              <a:off x="699973" y="1425304"/>
              <a:ext cx="0" cy="6012000"/>
            </a:xfrm>
            <a:prstGeom prst="straightConnector1">
              <a:avLst/>
            </a:prstGeom>
            <a:ln w="2857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 rot="16200000">
              <a:off x="129046" y="4240047"/>
              <a:ext cx="9124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human CD8</a:t>
              </a:r>
              <a:endParaRPr lang="en-US" sz="1200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517871" y="7412305"/>
              <a:ext cx="9124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human CD4</a:t>
              </a:r>
              <a:endParaRPr lang="en-US" sz="1200" dirty="0"/>
            </a:p>
          </p:txBody>
        </p:sp>
        <p:cxnSp>
          <p:nvCxnSpPr>
            <p:cNvPr id="27" name="Straight Arrow Connector 26"/>
            <p:cNvCxnSpPr/>
            <p:nvPr/>
          </p:nvCxnSpPr>
          <p:spPr>
            <a:xfrm>
              <a:off x="699973" y="7437302"/>
              <a:ext cx="4428000" cy="2"/>
            </a:xfrm>
            <a:prstGeom prst="straightConnector1">
              <a:avLst/>
            </a:prstGeom>
            <a:ln w="2857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/>
            <p:cNvSpPr txBox="1"/>
            <p:nvPr/>
          </p:nvSpPr>
          <p:spPr>
            <a:xfrm flipH="1">
              <a:off x="4927918" y="1901618"/>
              <a:ext cx="400110" cy="483338"/>
            </a:xfrm>
            <a:prstGeom prst="rect">
              <a:avLst/>
            </a:prstGeom>
            <a:noFill/>
          </p:spPr>
          <p:txBody>
            <a:bodyPr vert="vert270" wrap="none" rtlCol="0" anchor="ctr">
              <a:spAutoFit/>
            </a:bodyPr>
            <a:lstStyle/>
            <a:p>
              <a:pPr algn="ctr"/>
              <a:r>
                <a:rPr lang="de-DE" sz="1400" dirty="0"/>
                <a:t>day 0</a:t>
              </a:r>
              <a:endParaRPr lang="en-US" sz="1400" dirty="0"/>
            </a:p>
          </p:txBody>
        </p:sp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789122" y="1424768"/>
              <a:ext cx="1436289" cy="1440000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789122" y="5916115"/>
              <a:ext cx="1436289" cy="144000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2211400" y="5916115"/>
              <a:ext cx="1436289" cy="1440000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3633678" y="5916115"/>
              <a:ext cx="1436289" cy="144000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789122" y="4534538"/>
              <a:ext cx="1436289" cy="1440000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2211400" y="4534538"/>
              <a:ext cx="1436288" cy="1440000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3633678" y="4534538"/>
              <a:ext cx="1436289" cy="1440000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789122" y="3152960"/>
              <a:ext cx="1436289" cy="1440000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2211400" y="3152960"/>
              <a:ext cx="1436289" cy="1440000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3633678" y="3152960"/>
              <a:ext cx="1436289" cy="1440000"/>
            </a:xfrm>
            <a:prstGeom prst="rect">
              <a:avLst/>
            </a:prstGeom>
          </p:spPr>
        </p:pic>
      </p:grpSp>
      <p:sp>
        <p:nvSpPr>
          <p:cNvPr id="26" name="TextBox 25"/>
          <p:cNvSpPr txBox="1"/>
          <p:nvPr/>
        </p:nvSpPr>
        <p:spPr>
          <a:xfrm>
            <a:off x="699973" y="7833320"/>
            <a:ext cx="46280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/>
              <a:t>Supplementary Figure 3. Composition of T cell subsets during incubation with autologous CAR T cells.</a:t>
            </a:r>
            <a:r>
              <a:rPr lang="en-US" sz="1000" dirty="0"/>
              <a:t> 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xmlns="" val="960046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6DD05DE80388C46B1F7984416437388" ma:contentTypeVersion="13" ma:contentTypeDescription="Create a new document." ma:contentTypeScope="" ma:versionID="63c99ab67d1edbffad4ccbefde802ab3">
  <xsd:schema xmlns:xsd="http://www.w3.org/2001/XMLSchema" xmlns:xs="http://www.w3.org/2001/XMLSchema" xmlns:p="http://schemas.microsoft.com/office/2006/metadata/properties" xmlns:ns3="41fa00a4-50c0-4d8e-84a9-a9f152914fd2" xmlns:ns4="9540a979-5a1f-43a4-8ce4-412e8206e472" targetNamespace="http://schemas.microsoft.com/office/2006/metadata/properties" ma:root="true" ma:fieldsID="80c504b5826a8eb8238d16070e0b6d3e" ns3:_="" ns4:_="">
    <xsd:import namespace="41fa00a4-50c0-4d8e-84a9-a9f152914fd2"/>
    <xsd:import namespace="9540a979-5a1f-43a4-8ce4-412e8206e472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1fa00a4-50c0-4d8e-84a9-a9f152914fd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540a979-5a1f-43a4-8ce4-412e8206e472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11FB6372-DFA4-4194-A04D-5A31CA1C05D1}">
  <ds:schemaRefs>
    <ds:schemaRef ds:uri="http://schemas.microsoft.com/office/infopath/2007/PartnerControls"/>
    <ds:schemaRef ds:uri="41fa00a4-50c0-4d8e-84a9-a9f152914fd2"/>
    <ds:schemaRef ds:uri="http://purl.org/dc/elements/1.1/"/>
    <ds:schemaRef ds:uri="http://purl.org/dc/terms/"/>
    <ds:schemaRef ds:uri="http://schemas.microsoft.com/office/2006/metadata/properties"/>
    <ds:schemaRef ds:uri="http://schemas.microsoft.com/office/2006/documentManagement/types"/>
    <ds:schemaRef ds:uri="9540a979-5a1f-43a4-8ce4-412e8206e472"/>
    <ds:schemaRef ds:uri="http://purl.org/dc/dcmitype/"/>
    <ds:schemaRef ds:uri="http://schemas.openxmlformats.org/package/2006/metadata/core-properties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C2DB69B1-5322-40D4-BA88-AD164A26A6C0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8B9E28D-BA6B-458E-BE80-BB3A3F8BD83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1fa00a4-50c0-4d8e-84a9-a9f152914fd2"/>
    <ds:schemaRef ds:uri="9540a979-5a1f-43a4-8ce4-412e8206e47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87</Words>
  <Application>Microsoft Office PowerPoint</Application>
  <PresentationFormat>A4 Paper (210x297 mm)</PresentationFormat>
  <Paragraphs>27</Paragraphs>
  <Slides>3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lide 1</vt:lpstr>
      <vt:lpstr>Slide 2</vt:lpstr>
      <vt:lpstr>Slide 3</vt:lpstr>
    </vt:vector>
  </TitlesOfParts>
  <Company>Paul Ehrlich Institu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asic, Lea</dc:creator>
  <cp:lastModifiedBy>0009662</cp:lastModifiedBy>
  <cp:revision>455</cp:revision>
  <cp:lastPrinted>2016-12-16T13:10:13Z</cp:lastPrinted>
  <dcterms:created xsi:type="dcterms:W3CDTF">2016-03-23T13:35:56Z</dcterms:created>
  <dcterms:modified xsi:type="dcterms:W3CDTF">2020-08-25T11:32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6DD05DE80388C46B1F7984416437388</vt:lpwstr>
  </property>
</Properties>
</file>